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9" r:id="rId2"/>
  </p:sldIdLst>
  <p:sldSz cx="35999738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A9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20" d="100"/>
          <a:sy n="20" d="100"/>
        </p:scale>
        <p:origin x="255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5891626"/>
            <a:ext cx="30599777" cy="1253324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8908198"/>
            <a:ext cx="26999804" cy="8691601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63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129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916653"/>
            <a:ext cx="7762444" cy="305081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916653"/>
            <a:ext cx="22837334" cy="3050811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14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69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8974945"/>
            <a:ext cx="31049774" cy="14974888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4091502"/>
            <a:ext cx="31049774" cy="7874940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17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2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916661"/>
            <a:ext cx="31049774" cy="695828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8824938"/>
            <a:ext cx="15229574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3149904"/>
            <a:ext cx="15229574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8824938"/>
            <a:ext cx="15304578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3149904"/>
            <a:ext cx="15304578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98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822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519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183304"/>
            <a:ext cx="18224867" cy="25583147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693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183304"/>
            <a:ext cx="18224867" cy="25583147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480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916661"/>
            <a:ext cx="31049774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9583264"/>
            <a:ext cx="31049774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3366432"/>
            <a:ext cx="1214991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35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E950B4-89D3-4E2A-A3F1-6DF20248C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594309"/>
              </p:ext>
            </p:extLst>
          </p:nvPr>
        </p:nvGraphicFramePr>
        <p:xfrm>
          <a:off x="556029" y="2714430"/>
          <a:ext cx="31359481" cy="931332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587113">
                  <a:extLst>
                    <a:ext uri="{9D8B030D-6E8A-4147-A177-3AD203B41FA5}">
                      <a16:colId xmlns:a16="http://schemas.microsoft.com/office/drawing/2014/main" val="3780745624"/>
                    </a:ext>
                  </a:extLst>
                </a:gridCol>
                <a:gridCol w="3893574">
                  <a:extLst>
                    <a:ext uri="{9D8B030D-6E8A-4147-A177-3AD203B41FA5}">
                      <a16:colId xmlns:a16="http://schemas.microsoft.com/office/drawing/2014/main" val="499345670"/>
                    </a:ext>
                  </a:extLst>
                </a:gridCol>
                <a:gridCol w="4467026">
                  <a:extLst>
                    <a:ext uri="{9D8B030D-6E8A-4147-A177-3AD203B41FA5}">
                      <a16:colId xmlns:a16="http://schemas.microsoft.com/office/drawing/2014/main" val="2613630306"/>
                    </a:ext>
                  </a:extLst>
                </a:gridCol>
                <a:gridCol w="2566219">
                  <a:extLst>
                    <a:ext uri="{9D8B030D-6E8A-4147-A177-3AD203B41FA5}">
                      <a16:colId xmlns:a16="http://schemas.microsoft.com/office/drawing/2014/main" val="1333612574"/>
                    </a:ext>
                  </a:extLst>
                </a:gridCol>
                <a:gridCol w="3067665">
                  <a:extLst>
                    <a:ext uri="{9D8B030D-6E8A-4147-A177-3AD203B41FA5}">
                      <a16:colId xmlns:a16="http://schemas.microsoft.com/office/drawing/2014/main" val="242835973"/>
                    </a:ext>
                  </a:extLst>
                </a:gridCol>
                <a:gridCol w="5869858">
                  <a:extLst>
                    <a:ext uri="{9D8B030D-6E8A-4147-A177-3AD203B41FA5}">
                      <a16:colId xmlns:a16="http://schemas.microsoft.com/office/drawing/2014/main" val="2895600101"/>
                    </a:ext>
                  </a:extLst>
                </a:gridCol>
                <a:gridCol w="4277032">
                  <a:extLst>
                    <a:ext uri="{9D8B030D-6E8A-4147-A177-3AD203B41FA5}">
                      <a16:colId xmlns:a16="http://schemas.microsoft.com/office/drawing/2014/main" val="4006168732"/>
                    </a:ext>
                  </a:extLst>
                </a:gridCol>
                <a:gridCol w="2182761">
                  <a:extLst>
                    <a:ext uri="{9D8B030D-6E8A-4147-A177-3AD203B41FA5}">
                      <a16:colId xmlns:a16="http://schemas.microsoft.com/office/drawing/2014/main" val="872980562"/>
                    </a:ext>
                  </a:extLst>
                </a:gridCol>
                <a:gridCol w="2448233">
                  <a:extLst>
                    <a:ext uri="{9D8B030D-6E8A-4147-A177-3AD203B41FA5}">
                      <a16:colId xmlns:a16="http://schemas.microsoft.com/office/drawing/2014/main" val="4042322082"/>
                    </a:ext>
                  </a:extLst>
                </a:gridCol>
              </a:tblGrid>
              <a:tr h="992288"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utcom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xposur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gger intercept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xposur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gger intercept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9188143"/>
                  </a:ext>
                </a:extLst>
              </a:tr>
              <a:tr h="605923">
                <a:tc rowSpan="13">
                  <a:txBody>
                    <a:bodyPr/>
                    <a:lstStyle/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rvical spondylosis</a:t>
                      </a:r>
                    </a:p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B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3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3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5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2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0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6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065118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initi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7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1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3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jor de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51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8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07678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heavin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1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7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5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F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3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5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4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416304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coholic drink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1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1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tting height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1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2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1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0376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ffee intak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2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7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1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isure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52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05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03181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atching T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13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9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5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ysical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32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2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6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895405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sing compu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5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5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4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M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5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9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0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10387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3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2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8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W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8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5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7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960023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1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26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1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steoporo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2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5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3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47817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iglycerid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3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9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tal Testostero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3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9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08636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4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3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0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rum 25-Hydroxyvitamin 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4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4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0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85985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2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4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1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1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96676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sehold incom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4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8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8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holesterol, tot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0.001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4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16614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77402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01</TotalTime>
  <Words>157</Words>
  <Application>Microsoft Office PowerPoint</Application>
  <PresentationFormat>自定义</PresentationFormat>
  <Paragraphs>1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任震晓</dc:creator>
  <cp:lastModifiedBy>任震晓</cp:lastModifiedBy>
  <cp:revision>345</cp:revision>
  <dcterms:created xsi:type="dcterms:W3CDTF">2023-07-13T08:08:32Z</dcterms:created>
  <dcterms:modified xsi:type="dcterms:W3CDTF">2024-03-05T13:06:04Z</dcterms:modified>
</cp:coreProperties>
</file>